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3B3229-1337-4A3B-85B2-6291636AF654}" type="datetimeFigureOut">
              <a:rPr lang="en-GB" smtClean="0"/>
              <a:t>27/0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7F3030-2C48-493F-9863-E65D285D4D4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90676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11470C-3BF5-D546-A8B1-C0939EA687C7}" type="slidenum">
              <a:rPr lang="en-US" smtClean="0">
                <a:solidFill>
                  <a:prstClr val="black"/>
                </a:solidFill>
              </a:rPr>
              <a:pPr/>
              <a:t>1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627809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11470C-3BF5-D546-A8B1-C0939EA687C7}" type="slidenum">
              <a:rPr lang="en-US" smtClean="0">
                <a:solidFill>
                  <a:prstClr val="black"/>
                </a:solidFill>
              </a:rPr>
              <a:pPr/>
              <a:t>2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004470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11470C-3BF5-D546-A8B1-C0939EA687C7}" type="slidenum">
              <a:rPr lang="en-US" smtClean="0">
                <a:solidFill>
                  <a:prstClr val="black"/>
                </a:solidFill>
              </a:rPr>
              <a:pPr/>
              <a:t>3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639002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87978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51269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72387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77225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875355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787569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91402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56907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38343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87421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6434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018E73-5FC8-454F-A779-B9026FAA9367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9/27/2018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7E5863-3E83-F143-A95F-0850656E48E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34961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759922"/>
              </p:ext>
            </p:extLst>
          </p:nvPr>
        </p:nvGraphicFramePr>
        <p:xfrm>
          <a:off x="1524001" y="1114708"/>
          <a:ext cx="5900198" cy="4250756"/>
        </p:xfrm>
        <a:graphic>
          <a:graphicData uri="http://schemas.openxmlformats.org/drawingml/2006/table">
            <a:tbl>
              <a:tblPr/>
              <a:tblGrid>
                <a:gridCol w="1991897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435168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812861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500853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050296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517951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591172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</a:tblGrid>
              <a:tr h="215432">
                <a:tc gridSpan="7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upplementary Table S1: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mple Characteristics of the Comparisons between Probands and Control Subjects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</a:t>
                      </a: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HC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roband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Symbol" charset="2"/>
                          <a:cs typeface="Symbol" charset="2"/>
                        </a:rPr>
                        <a:t>c</a:t>
                      </a:r>
                      <a:r>
                        <a:rPr lang="fi-FI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  <a:r>
                        <a:rPr lang="fi-FI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, F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-value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ge (mean, SD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tr-T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6</a:t>
                      </a: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7.3 (12.4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80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5.2 (12.5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.7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100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ex (M/F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tr-T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6</a:t>
                      </a: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3/73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80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50/230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.6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pt-B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57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thnicity (AA/CA/OT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tr-T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6</a:t>
                      </a: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3/81/12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80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7/318/25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.3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192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ite (CT/GP/GT/JS/MB/MK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tr-T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6</a:t>
                      </a: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/33/37/31/0/20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80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0/117/130/112/12/49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.1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22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ACS Verbal Memory (mean, SD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6</a:t>
                      </a: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17 (1.0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1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81 (1.4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6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&lt;0.001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ACS Digit Sequence (mean, SD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6</a:t>
                      </a: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9 (1.0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1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87 (1.2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7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&lt;0.001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ACS Tower of London (mean, SD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6</a:t>
                      </a: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6 (1.1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1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0.51 (1.3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9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&lt;0.001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ACS Symbol Coding (mean, SD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16</a:t>
                      </a: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3 (1.1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1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1.2 (1.1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0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&lt;0.001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9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ANSS</a:t>
                      </a:r>
                      <a:r>
                        <a:rPr lang="en-US" sz="1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ositive Total Score (mean, SD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2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5.2 (5.5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0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ANSS Delusions Score (mean, SD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2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.5 (1.4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1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ANSS Hallucinations Score (mean, SD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-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72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.4 (1.5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2"/>
                  </a:ext>
                </a:extLst>
              </a:tr>
              <a:tr h="215432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Intracranial volume (mean, SD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9</a:t>
                      </a:r>
                    </a:p>
                  </a:txBody>
                  <a:tcPr marL="9525" marR="9525" marT="12700" marB="0"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.4e6 (1.8e5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84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.4e6 (1.8e5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94</a:t>
                      </a:r>
                    </a:p>
                  </a:txBody>
                  <a:tcPr marL="9525" marR="9525" marT="1270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330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13"/>
                  </a:ext>
                </a:extLst>
              </a:tr>
              <a:tr h="531399">
                <a:tc gridSpan="7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otes: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SD, standard deviation; AA, African American; OT, other; CA, Caucasian; CT=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Texa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; GP=Yale; GT=Maryland; JS=Chicago; MB=Wayne State; MK=Harvard; HC, healthy control; BPP, bipolar disorder psychotic; SADP, schizoaffective; SZP, schizophrenia; PANSS, Positive and Negative Syndrome Scale; BACS, Brief Assessment of Cognition;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charset="2"/>
                          <a:cs typeface="Symbol" charset="2"/>
                        </a:rPr>
                        <a:t>c</a:t>
                      </a:r>
                      <a:r>
                        <a:rPr lang="en-US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, chi square; F, f test.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697412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3969590"/>
              </p:ext>
            </p:extLst>
          </p:nvPr>
        </p:nvGraphicFramePr>
        <p:xfrm>
          <a:off x="1524000" y="1972191"/>
          <a:ext cx="6522077" cy="2020262"/>
        </p:xfrm>
        <a:graphic>
          <a:graphicData uri="http://schemas.openxmlformats.org/drawingml/2006/table">
            <a:tbl>
              <a:tblPr/>
              <a:tblGrid>
                <a:gridCol w="145470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957521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027799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869675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878460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746691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587226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</a:tblGrid>
              <a:tr h="254655">
                <a:tc gridSpan="7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upplementary Table S2: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mple Characteristics between Diagnostic Groups and Control Subjects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5465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HC (n=126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PP (n=205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D (n=112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Z (n=163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Symbol" charset="2"/>
                          <a:cs typeface="Symbol" charset="2"/>
                        </a:rPr>
                        <a:t>c</a:t>
                      </a:r>
                      <a:r>
                        <a:rPr lang="fi-FI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  <a:r>
                        <a:rPr lang="fi-FI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, F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-value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22070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ge (mean, SD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7.3 (12.4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5.8 (12.7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6.1 (12.3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3.8 (12.3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.99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115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20701">
                <a:tc>
                  <a:txBody>
                    <a:bodyPr/>
                    <a:lstStyle/>
                    <a:p>
                      <a:pPr algn="l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ex (M/F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3/73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5/130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4/58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1/42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6.4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&lt;0.001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2070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thnicity (AA/CA/OT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3/81/12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0/157/8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4/71/7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3/90/10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2.8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&lt;0.001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20701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ite (CT/GP/GT/JS/MK)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/33/37/31/20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5/40/45/60/35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3/41/23/22/3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/36/62/30/23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0.9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&lt;0.001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628148">
                <a:tc gridSpan="7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otes: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SD, standard deviation; AA, African American; OT, other; CA, Caucasian; CT=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UTexas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; GP=Yale; GT=Maryland; JS=Chicago; MB=Wayne State; MK=Harvard; HC, healthy controls; BPP, psychotic bipolar disorder; SAD, schizoaffective disorder; SZ, schizophrenia;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Symbol" charset="2"/>
                          <a:cs typeface="Symbol" charset="2"/>
                        </a:rPr>
                        <a:t>c</a:t>
                      </a:r>
                      <a:r>
                        <a:rPr lang="en-US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, chi square; F, f test.</a:t>
                      </a:r>
                    </a:p>
                  </a:txBody>
                  <a:tcPr marL="9525" marR="9525" marT="1270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489754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9222190"/>
              </p:ext>
            </p:extLst>
          </p:nvPr>
        </p:nvGraphicFramePr>
        <p:xfrm>
          <a:off x="1074761" y="1236073"/>
          <a:ext cx="7338365" cy="2890793"/>
        </p:xfrm>
        <a:graphic>
          <a:graphicData uri="http://schemas.openxmlformats.org/drawingml/2006/table">
            <a:tbl>
              <a:tblPr/>
              <a:tblGrid>
                <a:gridCol w="1056365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69506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624680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369530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483908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633479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  <a:gridCol w="633479">
                  <a:extLst>
                    <a:ext uri="{9D8B030D-6E8A-4147-A177-3AD203B41FA5}">
                      <a16:colId xmlns="" xmlns:a16="http://schemas.microsoft.com/office/drawing/2014/main" val="20006"/>
                    </a:ext>
                  </a:extLst>
                </a:gridCol>
                <a:gridCol w="360731">
                  <a:extLst>
                    <a:ext uri="{9D8B030D-6E8A-4147-A177-3AD203B41FA5}">
                      <a16:colId xmlns="" xmlns:a16="http://schemas.microsoft.com/office/drawing/2014/main" val="20007"/>
                    </a:ext>
                  </a:extLst>
                </a:gridCol>
                <a:gridCol w="413521">
                  <a:extLst>
                    <a:ext uri="{9D8B030D-6E8A-4147-A177-3AD203B41FA5}">
                      <a16:colId xmlns="" xmlns:a16="http://schemas.microsoft.com/office/drawing/2014/main" val="20008"/>
                    </a:ext>
                  </a:extLst>
                </a:gridCol>
                <a:gridCol w="624680">
                  <a:extLst>
                    <a:ext uri="{9D8B030D-6E8A-4147-A177-3AD203B41FA5}">
                      <a16:colId xmlns="" xmlns:a16="http://schemas.microsoft.com/office/drawing/2014/main" val="20009"/>
                    </a:ext>
                  </a:extLst>
                </a:gridCol>
                <a:gridCol w="730261">
                  <a:extLst>
                    <a:ext uri="{9D8B030D-6E8A-4147-A177-3AD203B41FA5}">
                      <a16:colId xmlns="" xmlns:a16="http://schemas.microsoft.com/office/drawing/2014/main" val="20010"/>
                    </a:ext>
                  </a:extLst>
                </a:gridCol>
                <a:gridCol w="334336">
                  <a:extLst>
                    <a:ext uri="{9D8B030D-6E8A-4147-A177-3AD203B41FA5}">
                      <a16:colId xmlns="" xmlns:a16="http://schemas.microsoft.com/office/drawing/2014/main" val="20011"/>
                    </a:ext>
                  </a:extLst>
                </a:gridCol>
                <a:gridCol w="378328">
                  <a:extLst>
                    <a:ext uri="{9D8B030D-6E8A-4147-A177-3AD203B41FA5}">
                      <a16:colId xmlns="" xmlns:a16="http://schemas.microsoft.com/office/drawing/2014/main" val="20012"/>
                    </a:ext>
                  </a:extLst>
                </a:gridCol>
              </a:tblGrid>
              <a:tr h="198114">
                <a:tc gridSpan="13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upplementary Table S3: 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ample Characteristics by Allele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248315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sk-SK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</a:t>
                      </a:r>
                      <a:r>
                        <a:rPr lang="cs-CZ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699947do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cs-CZ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sk-SK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</a:t>
                      </a:r>
                      <a:r>
                        <a:rPr lang="cs-CZ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833070do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cs-CZ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sk-SK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 </a:t>
                      </a:r>
                      <a:r>
                        <a:rPr lang="sk-SK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r</a:t>
                      </a:r>
                      <a:r>
                        <a:rPr lang="is-I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2146323do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is-IS" sz="10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endParaRPr lang="sk-SK" sz="10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7990" marR="7990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198114">
                <a:tc>
                  <a:txBody>
                    <a:bodyPr/>
                    <a:lstStyle/>
                    <a:p>
                      <a:pPr algn="l" fontAlgn="b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  <a:cs typeface="Arial"/>
                      </a:endParaRP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T-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Symbol" charset="2"/>
                          <a:cs typeface="Symbol" charset="2"/>
                        </a:rPr>
                        <a:t>c</a:t>
                      </a:r>
                      <a:r>
                        <a:rPr lang="fi-FI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  <a:r>
                        <a:rPr lang="fi-FI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, F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-value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-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G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Symbol" charset="2"/>
                          <a:cs typeface="Symbol" charset="2"/>
                        </a:rPr>
                        <a:t>c</a:t>
                      </a:r>
                      <a:r>
                        <a:rPr lang="fi-FI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  <a:r>
                        <a:rPr lang="fi-FI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, F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-value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-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CC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Symbol" charset="2"/>
                          <a:cs typeface="Symbol" charset="2"/>
                        </a:rPr>
                        <a:t>c</a:t>
                      </a:r>
                      <a:r>
                        <a:rPr lang="fi-FI" sz="10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  <a:r>
                        <a:rPr lang="fi-FI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, F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-value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24667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Age (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ean,SD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)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4.9 (12.4)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6.6 (12.5)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.26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133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5.3 (12.5)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6.3 (12.4)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90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343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5.4 (12.4)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35.7 (12.6)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8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776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255368">
                <a:tc>
                  <a:txBody>
                    <a:bodyPr/>
                    <a:lstStyle/>
                    <a:p>
                      <a:pPr algn="l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Sex (M/F)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84/168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2/107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50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479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97/195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5/108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2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888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60/148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9/150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74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uk-UA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391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270414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Ethnicity (AA/CA/OT)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9/269/24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0/97/12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3.0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&lt;0.001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6/291/25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93/108/12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0.8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&lt;0.001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1/225/22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6/168/15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1.1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&lt;0.001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3863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Diagnosis group (BPP/NC/SAD/SZ)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22/75/63/92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3/40/42/64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.40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494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33/89/70/100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2/37/42/62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.81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422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4/71/51/82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101/47/60/81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.06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167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386358"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Biotype group (1P/2P/3P/NC)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8/82/117/75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1/46/66/40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.60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203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5/92/124/89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52/48/71/37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hr-HR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.22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i-FI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101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49/72/97/71</a:t>
                      </a:r>
                    </a:p>
                  </a:txBody>
                  <a:tcPr marL="5993" marR="5993" marT="7990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mr-IN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68/69/97/47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7.92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48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386358">
                <a:tc gridSpan="13">
                  <a:txBody>
                    <a:bodyPr/>
                    <a:lstStyle/>
                    <a:p>
                      <a:pPr algn="l" fontAlgn="b"/>
                      <a:r>
                        <a:rPr lang="en-US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Notes: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 SD, standard deviation; M, Male; F, Female; AA, African American; OT, other; CA, Caucasian; HC, healthy controls; BPP, psychotic bipolar disorder; SAD, schizoaffective disorder; SZ, schizophrenia; 1P=Biotype 1; 2P=Biotype 2; 3P=Biotype 3; </a:t>
                      </a:r>
                      <a:r>
                        <a:rPr lang="fi-FI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Symbol" charset="2"/>
                          <a:cs typeface="Symbol" charset="2"/>
                        </a:rPr>
                        <a:t>c</a:t>
                      </a:r>
                      <a:r>
                        <a:rPr lang="en-US" sz="10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2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, chi square; F, f test.</a:t>
                      </a:r>
                    </a:p>
                  </a:txBody>
                  <a:tcPr marL="5993" marR="5993" marT="799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63545172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54</Words>
  <Application>Microsoft Office PowerPoint</Application>
  <PresentationFormat>On-screen Show (4:3)</PresentationFormat>
  <Paragraphs>204</Paragraphs>
  <Slides>3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1_Office Theme</vt:lpstr>
      <vt:lpstr>PowerPoint Presentation</vt:lpstr>
      <vt:lpstr>PowerPoint Presentation</vt:lpstr>
      <vt:lpstr>PowerPoint Presentation</vt:lpstr>
    </vt:vector>
  </TitlesOfParts>
  <Company>Springer-SB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ms, Melissa</dc:creator>
  <cp:lastModifiedBy>Sims, Melissa</cp:lastModifiedBy>
  <cp:revision>1</cp:revision>
  <dcterms:created xsi:type="dcterms:W3CDTF">2018-09-27T10:36:53Z</dcterms:created>
  <dcterms:modified xsi:type="dcterms:W3CDTF">2018-09-27T10:37:43Z</dcterms:modified>
</cp:coreProperties>
</file>